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235825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3" autoAdjust="0"/>
    <p:restoredTop sz="94660"/>
  </p:normalViewPr>
  <p:slideViewPr>
    <p:cSldViewPr snapToGrid="0">
      <p:cViewPr>
        <p:scale>
          <a:sx n="66" d="100"/>
          <a:sy n="66" d="100"/>
        </p:scale>
        <p:origin x="2400" y="-8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2687" y="1995312"/>
            <a:ext cx="6150451" cy="4244622"/>
          </a:xfrm>
        </p:spPr>
        <p:txBody>
          <a:bodyPr anchor="b"/>
          <a:lstStyle>
            <a:lvl1pPr algn="ctr">
              <a:defRPr sz="4748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04478" y="6403623"/>
            <a:ext cx="5426869" cy="2943577"/>
          </a:xfrm>
        </p:spPr>
        <p:txBody>
          <a:bodyPr/>
          <a:lstStyle>
            <a:lvl1pPr marL="0" indent="0" algn="ctr">
              <a:buNone/>
              <a:defRPr sz="1899"/>
            </a:lvl1pPr>
            <a:lvl2pPr marL="361782" indent="0" algn="ctr">
              <a:buNone/>
              <a:defRPr sz="1583"/>
            </a:lvl2pPr>
            <a:lvl3pPr marL="723565" indent="0" algn="ctr">
              <a:buNone/>
              <a:defRPr sz="1424"/>
            </a:lvl3pPr>
            <a:lvl4pPr marL="1085347" indent="0" algn="ctr">
              <a:buNone/>
              <a:defRPr sz="1266"/>
            </a:lvl4pPr>
            <a:lvl5pPr marL="1447129" indent="0" algn="ctr">
              <a:buNone/>
              <a:defRPr sz="1266"/>
            </a:lvl5pPr>
            <a:lvl6pPr marL="1808912" indent="0" algn="ctr">
              <a:buNone/>
              <a:defRPr sz="1266"/>
            </a:lvl6pPr>
            <a:lvl7pPr marL="2170694" indent="0" algn="ctr">
              <a:buNone/>
              <a:defRPr sz="1266"/>
            </a:lvl7pPr>
            <a:lvl8pPr marL="2532477" indent="0" algn="ctr">
              <a:buNone/>
              <a:defRPr sz="1266"/>
            </a:lvl8pPr>
            <a:lvl9pPr marL="2894259" indent="0" algn="ctr">
              <a:buNone/>
              <a:defRPr sz="1266"/>
            </a:lvl9pPr>
          </a:lstStyle>
          <a:p>
            <a:r>
              <a:rPr lang="nl-NL" smtClean="0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61147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76926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78138" y="649111"/>
            <a:ext cx="1560225" cy="10332156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7464" y="649111"/>
            <a:ext cx="4590226" cy="10332156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39531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68904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695" y="3039537"/>
            <a:ext cx="6240899" cy="5071532"/>
          </a:xfrm>
        </p:spPr>
        <p:txBody>
          <a:bodyPr anchor="b"/>
          <a:lstStyle>
            <a:lvl1pPr>
              <a:defRPr sz="4748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3695" y="8159048"/>
            <a:ext cx="6240899" cy="2666999"/>
          </a:xfrm>
        </p:spPr>
        <p:txBody>
          <a:bodyPr/>
          <a:lstStyle>
            <a:lvl1pPr marL="0" indent="0">
              <a:buNone/>
              <a:defRPr sz="1899">
                <a:solidFill>
                  <a:schemeClr val="tx1"/>
                </a:solidFill>
              </a:defRPr>
            </a:lvl1pPr>
            <a:lvl2pPr marL="361782" indent="0">
              <a:buNone/>
              <a:defRPr sz="1583">
                <a:solidFill>
                  <a:schemeClr val="tx1">
                    <a:tint val="75000"/>
                  </a:schemeClr>
                </a:solidFill>
              </a:defRPr>
            </a:lvl2pPr>
            <a:lvl3pPr marL="723565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3pPr>
            <a:lvl4pPr marL="1085347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4pPr>
            <a:lvl5pPr marL="1447129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5pPr>
            <a:lvl6pPr marL="1808912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6pPr>
            <a:lvl7pPr marL="2170694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7pPr>
            <a:lvl8pPr marL="2532477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8pPr>
            <a:lvl9pPr marL="2894259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53224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7463" y="3245556"/>
            <a:ext cx="3075226" cy="7735712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63136" y="3245556"/>
            <a:ext cx="3075226" cy="7735712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81779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649114"/>
            <a:ext cx="6240899" cy="2356556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8406" y="2988734"/>
            <a:ext cx="3061093" cy="1464732"/>
          </a:xfrm>
        </p:spPr>
        <p:txBody>
          <a:bodyPr anchor="b"/>
          <a:lstStyle>
            <a:lvl1pPr marL="0" indent="0">
              <a:buNone/>
              <a:defRPr sz="1899" b="1"/>
            </a:lvl1pPr>
            <a:lvl2pPr marL="361782" indent="0">
              <a:buNone/>
              <a:defRPr sz="1583" b="1"/>
            </a:lvl2pPr>
            <a:lvl3pPr marL="723565" indent="0">
              <a:buNone/>
              <a:defRPr sz="1424" b="1"/>
            </a:lvl3pPr>
            <a:lvl4pPr marL="1085347" indent="0">
              <a:buNone/>
              <a:defRPr sz="1266" b="1"/>
            </a:lvl4pPr>
            <a:lvl5pPr marL="1447129" indent="0">
              <a:buNone/>
              <a:defRPr sz="1266" b="1"/>
            </a:lvl5pPr>
            <a:lvl6pPr marL="1808912" indent="0">
              <a:buNone/>
              <a:defRPr sz="1266" b="1"/>
            </a:lvl6pPr>
            <a:lvl7pPr marL="2170694" indent="0">
              <a:buNone/>
              <a:defRPr sz="1266" b="1"/>
            </a:lvl7pPr>
            <a:lvl8pPr marL="2532477" indent="0">
              <a:buNone/>
              <a:defRPr sz="1266" b="1"/>
            </a:lvl8pPr>
            <a:lvl9pPr marL="2894259" indent="0">
              <a:buNone/>
              <a:defRPr sz="1266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8406" y="4453467"/>
            <a:ext cx="3061093" cy="6550379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63137" y="2988734"/>
            <a:ext cx="3076168" cy="1464732"/>
          </a:xfrm>
        </p:spPr>
        <p:txBody>
          <a:bodyPr anchor="b"/>
          <a:lstStyle>
            <a:lvl1pPr marL="0" indent="0">
              <a:buNone/>
              <a:defRPr sz="1899" b="1"/>
            </a:lvl1pPr>
            <a:lvl2pPr marL="361782" indent="0">
              <a:buNone/>
              <a:defRPr sz="1583" b="1"/>
            </a:lvl2pPr>
            <a:lvl3pPr marL="723565" indent="0">
              <a:buNone/>
              <a:defRPr sz="1424" b="1"/>
            </a:lvl3pPr>
            <a:lvl4pPr marL="1085347" indent="0">
              <a:buNone/>
              <a:defRPr sz="1266" b="1"/>
            </a:lvl4pPr>
            <a:lvl5pPr marL="1447129" indent="0">
              <a:buNone/>
              <a:defRPr sz="1266" b="1"/>
            </a:lvl5pPr>
            <a:lvl6pPr marL="1808912" indent="0">
              <a:buNone/>
              <a:defRPr sz="1266" b="1"/>
            </a:lvl6pPr>
            <a:lvl7pPr marL="2170694" indent="0">
              <a:buNone/>
              <a:defRPr sz="1266" b="1"/>
            </a:lvl7pPr>
            <a:lvl8pPr marL="2532477" indent="0">
              <a:buNone/>
              <a:defRPr sz="1266" b="1"/>
            </a:lvl8pPr>
            <a:lvl9pPr marL="2894259" indent="0">
              <a:buNone/>
              <a:defRPr sz="1266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63137" y="4453467"/>
            <a:ext cx="3076168" cy="6550379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45388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94238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43780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812800"/>
            <a:ext cx="2333742" cy="2844800"/>
          </a:xfrm>
        </p:spPr>
        <p:txBody>
          <a:bodyPr anchor="b"/>
          <a:lstStyle>
            <a:lvl1pPr>
              <a:defRPr sz="2532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76168" y="1755425"/>
            <a:ext cx="3663136" cy="8664222"/>
          </a:xfrm>
        </p:spPr>
        <p:txBody>
          <a:bodyPr/>
          <a:lstStyle>
            <a:lvl1pPr>
              <a:defRPr sz="2532"/>
            </a:lvl1pPr>
            <a:lvl2pPr>
              <a:defRPr sz="2216"/>
            </a:lvl2pPr>
            <a:lvl3pPr>
              <a:defRPr sz="1899"/>
            </a:lvl3pPr>
            <a:lvl4pPr>
              <a:defRPr sz="1583"/>
            </a:lvl4pPr>
            <a:lvl5pPr>
              <a:defRPr sz="1583"/>
            </a:lvl5pPr>
            <a:lvl6pPr>
              <a:defRPr sz="1583"/>
            </a:lvl6pPr>
            <a:lvl7pPr>
              <a:defRPr sz="1583"/>
            </a:lvl7pPr>
            <a:lvl8pPr>
              <a:defRPr sz="1583"/>
            </a:lvl8pPr>
            <a:lvl9pPr>
              <a:defRPr sz="1583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405" y="3657600"/>
            <a:ext cx="2333742" cy="6776156"/>
          </a:xfrm>
        </p:spPr>
        <p:txBody>
          <a:bodyPr/>
          <a:lstStyle>
            <a:lvl1pPr marL="0" indent="0">
              <a:buNone/>
              <a:defRPr sz="1266"/>
            </a:lvl1pPr>
            <a:lvl2pPr marL="361782" indent="0">
              <a:buNone/>
              <a:defRPr sz="1108"/>
            </a:lvl2pPr>
            <a:lvl3pPr marL="723565" indent="0">
              <a:buNone/>
              <a:defRPr sz="950"/>
            </a:lvl3pPr>
            <a:lvl4pPr marL="1085347" indent="0">
              <a:buNone/>
              <a:defRPr sz="791"/>
            </a:lvl4pPr>
            <a:lvl5pPr marL="1447129" indent="0">
              <a:buNone/>
              <a:defRPr sz="791"/>
            </a:lvl5pPr>
            <a:lvl6pPr marL="1808912" indent="0">
              <a:buNone/>
              <a:defRPr sz="791"/>
            </a:lvl6pPr>
            <a:lvl7pPr marL="2170694" indent="0">
              <a:buNone/>
              <a:defRPr sz="791"/>
            </a:lvl7pPr>
            <a:lvl8pPr marL="2532477" indent="0">
              <a:buNone/>
              <a:defRPr sz="791"/>
            </a:lvl8pPr>
            <a:lvl9pPr marL="2894259" indent="0">
              <a:buNone/>
              <a:defRPr sz="79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39158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812800"/>
            <a:ext cx="2333742" cy="2844800"/>
          </a:xfrm>
        </p:spPr>
        <p:txBody>
          <a:bodyPr anchor="b"/>
          <a:lstStyle>
            <a:lvl1pPr>
              <a:defRPr sz="2532"/>
            </a:lvl1pPr>
          </a:lstStyle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76168" y="1755425"/>
            <a:ext cx="3663136" cy="8664222"/>
          </a:xfrm>
        </p:spPr>
        <p:txBody>
          <a:bodyPr anchor="t"/>
          <a:lstStyle>
            <a:lvl1pPr marL="0" indent="0">
              <a:buNone/>
              <a:defRPr sz="2532"/>
            </a:lvl1pPr>
            <a:lvl2pPr marL="361782" indent="0">
              <a:buNone/>
              <a:defRPr sz="2216"/>
            </a:lvl2pPr>
            <a:lvl3pPr marL="723565" indent="0">
              <a:buNone/>
              <a:defRPr sz="1899"/>
            </a:lvl3pPr>
            <a:lvl4pPr marL="1085347" indent="0">
              <a:buNone/>
              <a:defRPr sz="1583"/>
            </a:lvl4pPr>
            <a:lvl5pPr marL="1447129" indent="0">
              <a:buNone/>
              <a:defRPr sz="1583"/>
            </a:lvl5pPr>
            <a:lvl6pPr marL="1808912" indent="0">
              <a:buNone/>
              <a:defRPr sz="1583"/>
            </a:lvl6pPr>
            <a:lvl7pPr marL="2170694" indent="0">
              <a:buNone/>
              <a:defRPr sz="1583"/>
            </a:lvl7pPr>
            <a:lvl8pPr marL="2532477" indent="0">
              <a:buNone/>
              <a:defRPr sz="1583"/>
            </a:lvl8pPr>
            <a:lvl9pPr marL="2894259" indent="0">
              <a:buNone/>
              <a:defRPr sz="1583"/>
            </a:lvl9pPr>
          </a:lstStyle>
          <a:p>
            <a:r>
              <a:rPr lang="nl-NL" smtClean="0"/>
              <a:t>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405" y="3657600"/>
            <a:ext cx="2333742" cy="6776156"/>
          </a:xfrm>
        </p:spPr>
        <p:txBody>
          <a:bodyPr/>
          <a:lstStyle>
            <a:lvl1pPr marL="0" indent="0">
              <a:buNone/>
              <a:defRPr sz="1266"/>
            </a:lvl1pPr>
            <a:lvl2pPr marL="361782" indent="0">
              <a:buNone/>
              <a:defRPr sz="1108"/>
            </a:lvl2pPr>
            <a:lvl3pPr marL="723565" indent="0">
              <a:buNone/>
              <a:defRPr sz="950"/>
            </a:lvl3pPr>
            <a:lvl4pPr marL="1085347" indent="0">
              <a:buNone/>
              <a:defRPr sz="791"/>
            </a:lvl4pPr>
            <a:lvl5pPr marL="1447129" indent="0">
              <a:buNone/>
              <a:defRPr sz="791"/>
            </a:lvl5pPr>
            <a:lvl6pPr marL="1808912" indent="0">
              <a:buNone/>
              <a:defRPr sz="791"/>
            </a:lvl6pPr>
            <a:lvl7pPr marL="2170694" indent="0">
              <a:buNone/>
              <a:defRPr sz="791"/>
            </a:lvl7pPr>
            <a:lvl8pPr marL="2532477" indent="0">
              <a:buNone/>
              <a:defRPr sz="791"/>
            </a:lvl8pPr>
            <a:lvl9pPr marL="2894259" indent="0">
              <a:buNone/>
              <a:defRPr sz="79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44070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7463" y="649114"/>
            <a:ext cx="6240899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7463" y="3245556"/>
            <a:ext cx="6240899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7463" y="11300181"/>
            <a:ext cx="1628061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D15DA-218C-40C1-9011-5DEACD30FA74}" type="datetimeFigureOut">
              <a:rPr lang="nl-NL" smtClean="0"/>
              <a:t>18-10-2023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96867" y="11300181"/>
            <a:ext cx="2442091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10301" y="11300181"/>
            <a:ext cx="1628061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FB5978-7140-4B72-A3C5-9D4E6B810714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96719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23565" rtl="0" eaLnBrk="1" latinLnBrk="0" hangingPunct="1">
        <a:lnSpc>
          <a:spcPct val="90000"/>
        </a:lnSpc>
        <a:spcBef>
          <a:spcPct val="0"/>
        </a:spcBef>
        <a:buNone/>
        <a:defRPr sz="34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891" indent="-180891" algn="l" defTabSz="723565" rtl="0" eaLnBrk="1" latinLnBrk="0" hangingPunct="1">
        <a:lnSpc>
          <a:spcPct val="90000"/>
        </a:lnSpc>
        <a:spcBef>
          <a:spcPts val="791"/>
        </a:spcBef>
        <a:buFont typeface="Arial" panose="020B0604020202020204" pitchFamily="34" charset="0"/>
        <a:buChar char="•"/>
        <a:defRPr sz="2216" kern="1200">
          <a:solidFill>
            <a:schemeClr val="tx1"/>
          </a:solidFill>
          <a:latin typeface="+mn-lt"/>
          <a:ea typeface="+mn-ea"/>
          <a:cs typeface="+mn-cs"/>
        </a:defRPr>
      </a:lvl1pPr>
      <a:lvl2pPr marL="542674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899" kern="1200">
          <a:solidFill>
            <a:schemeClr val="tx1"/>
          </a:solidFill>
          <a:latin typeface="+mn-lt"/>
          <a:ea typeface="+mn-ea"/>
          <a:cs typeface="+mn-cs"/>
        </a:defRPr>
      </a:lvl2pPr>
      <a:lvl3pPr marL="904456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583" kern="1200">
          <a:solidFill>
            <a:schemeClr val="tx1"/>
          </a:solidFill>
          <a:latin typeface="+mn-lt"/>
          <a:ea typeface="+mn-ea"/>
          <a:cs typeface="+mn-cs"/>
        </a:defRPr>
      </a:lvl3pPr>
      <a:lvl4pPr marL="1266238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4pPr>
      <a:lvl5pPr marL="1628021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5pPr>
      <a:lvl6pPr marL="1989803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6pPr>
      <a:lvl7pPr marL="2351585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7pPr>
      <a:lvl8pPr marL="2713368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8pPr>
      <a:lvl9pPr marL="3075150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1pPr>
      <a:lvl2pPr marL="361782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2pPr>
      <a:lvl3pPr marL="723565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3pPr>
      <a:lvl4pPr marL="1085347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4pPr>
      <a:lvl5pPr marL="1447129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5pPr>
      <a:lvl6pPr marL="1808912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6pPr>
      <a:lvl7pPr marL="2170694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7pPr>
      <a:lvl8pPr marL="2532477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8pPr>
      <a:lvl9pPr marL="2894259" algn="l" defTabSz="723565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4383610"/>
              </p:ext>
            </p:extLst>
          </p:nvPr>
        </p:nvGraphicFramePr>
        <p:xfrm>
          <a:off x="1552947" y="164585"/>
          <a:ext cx="5506220" cy="1193853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738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738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7387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58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387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7387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73876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658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29143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  <a:gridCol w="60403">
                  <a:extLst>
                    <a:ext uri="{9D8B030D-6E8A-4147-A177-3AD203B41FA5}">
                      <a16:colId xmlns:a16="http://schemas.microsoft.com/office/drawing/2014/main" val="3573022524"/>
                    </a:ext>
                  </a:extLst>
                </a:gridCol>
                <a:gridCol w="403200">
                  <a:extLst>
                    <a:ext uri="{9D8B030D-6E8A-4147-A177-3AD203B41FA5}">
                      <a16:colId xmlns:a16="http://schemas.microsoft.com/office/drawing/2014/main" val="3527395526"/>
                    </a:ext>
                  </a:extLst>
                </a:gridCol>
                <a:gridCol w="60403">
                  <a:extLst>
                    <a:ext uri="{9D8B030D-6E8A-4147-A177-3AD203B41FA5}">
                      <a16:colId xmlns:a16="http://schemas.microsoft.com/office/drawing/2014/main" val="2742277172"/>
                    </a:ext>
                  </a:extLst>
                </a:gridCol>
                <a:gridCol w="644777">
                  <a:extLst>
                    <a:ext uri="{9D8B030D-6E8A-4147-A177-3AD203B41FA5}">
                      <a16:colId xmlns:a16="http://schemas.microsoft.com/office/drawing/2014/main" val="4079340589"/>
                    </a:ext>
                  </a:extLst>
                </a:gridCol>
                <a:gridCol w="60403">
                  <a:extLst>
                    <a:ext uri="{9D8B030D-6E8A-4147-A177-3AD203B41FA5}">
                      <a16:colId xmlns:a16="http://schemas.microsoft.com/office/drawing/2014/main" val="448899497"/>
                    </a:ext>
                  </a:extLst>
                </a:gridCol>
                <a:gridCol w="1131457">
                  <a:extLst>
                    <a:ext uri="{9D8B030D-6E8A-4147-A177-3AD203B41FA5}">
                      <a16:colId xmlns:a16="http://schemas.microsoft.com/office/drawing/2014/main" val="2431849840"/>
                    </a:ext>
                  </a:extLst>
                </a:gridCol>
              </a:tblGrid>
              <a:tr h="185536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nl-NL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3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nl-NL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00" marR="4600" marT="46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nl-NL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00" marR="4600" marT="46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nl-NL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6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nl-NL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00" marR="4600" marT="46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nl-NL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00" marR="4600" marT="46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nl-NL" sz="10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nl-NL" sz="1000" b="1" u="none" strike="noStrike" dirty="0" smtClean="0">
                          <a:effectLst/>
                        </a:rPr>
                        <a:t>ID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nl-NL" sz="10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t</a:t>
                      </a:r>
                      <a:r>
                        <a:rPr lang="nl-NL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. No.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nl-NL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ospital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nl-NL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Ward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5536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1" u="none" strike="noStrike" dirty="0" smtClean="0">
                          <a:effectLst/>
                        </a:rPr>
                        <a:t>a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1" u="none" strike="noStrike" dirty="0" smtClean="0">
                          <a:effectLst/>
                        </a:rPr>
                        <a:t>b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1" u="none" strike="noStrike" dirty="0" smtClean="0">
                          <a:effectLst/>
                        </a:rPr>
                        <a:t>c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1" u="none" strike="noStrike" dirty="0" smtClean="0">
                          <a:effectLst/>
                        </a:rPr>
                        <a:t>a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1" u="none" strike="noStrike" dirty="0" smtClean="0">
                          <a:effectLst/>
                        </a:rPr>
                        <a:t>b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1" u="none" strike="noStrike" dirty="0" smtClean="0">
                          <a:effectLst/>
                        </a:rPr>
                        <a:t>c</a:t>
                      </a:r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nl-NL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00" marR="4600" marT="46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T>
                      <a:noFill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0</a:t>
                      </a:r>
                    </a:p>
                  </a:txBody>
                  <a:tcPr marL="14293" marR="14293" marT="1429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nl-NL" sz="1000" b="0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mergenc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mergenc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Hematolog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mergenc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Medicine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</a:t>
                      </a:r>
                      <a:r>
                        <a:rPr lang="nl-NL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eneral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Medicine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Medicine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/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1/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</a:t>
                      </a:r>
                      <a:r>
                        <a:rPr lang="nl-NL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Medicine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</a:t>
                      </a:r>
                      <a:r>
                        <a:rPr lang="nl-NL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urning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8419937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ematolog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3295188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urning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3090926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/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2 Bahman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3706982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/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2 Bahman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1990616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/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92112761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/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5274272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/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mergenc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8959459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/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130226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/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ediatrics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1406828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/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mergenc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2932880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/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/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Medicine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3796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/4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rger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9642288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/4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2603667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/4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6965626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eart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48517256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/4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rger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8839875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/4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30789783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/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1085955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/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Medicine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8535889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1/5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</a:t>
                      </a:r>
                      <a:r>
                        <a:rPr lang="nl-NL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urning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3319933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ung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3993720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3982986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</a:t>
                      </a:r>
                      <a:r>
                        <a:rPr lang="nl-NL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urning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9514690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ry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12217114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fection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3670783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Hematolog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9438411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</a:t>
                      </a:r>
                      <a:r>
                        <a:rPr lang="nl-NL" sz="10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8607204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1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0056973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urning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1232241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ung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2087306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ung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33425235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4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Medicine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7950595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mergenc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6193319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/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r. Sheykh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Hematology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2533523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9/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35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urning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776371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5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CU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0693755"/>
                  </a:ext>
                </a:extLst>
              </a:tr>
              <a:tr h="202938"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R>
                      <a:noFill/>
                    </a:ln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/12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J26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mam Reza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l-NL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nal Medicine</a:t>
                      </a:r>
                      <a:endParaRPr lang="nl-NL" sz="1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4293" marR="14293" marT="14293" marB="0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4751488"/>
                  </a:ext>
                </a:extLst>
              </a:tr>
            </a:tbl>
          </a:graphicData>
        </a:graphic>
      </p:graphicFrame>
      <p:pic>
        <p:nvPicPr>
          <p:cNvPr id="2" name="Afbeelding 1"/>
          <p:cNvPicPr>
            <a:picLocks noChangeAspect="1"/>
          </p:cNvPicPr>
          <p:nvPr/>
        </p:nvPicPr>
        <p:blipFill rotWithShape="1">
          <a:blip r:embed="rId2"/>
          <a:srcRect t="6530" r="59743" b="965"/>
          <a:stretch/>
        </p:blipFill>
        <p:spPr>
          <a:xfrm>
            <a:off x="25401" y="591549"/>
            <a:ext cx="1527546" cy="11511573"/>
          </a:xfrm>
          <a:prstGeom prst="rect">
            <a:avLst/>
          </a:prstGeom>
        </p:spPr>
      </p:pic>
      <p:cxnSp>
        <p:nvCxnSpPr>
          <p:cNvPr id="5" name="Rechte verbindingslijn 4"/>
          <p:cNvCxnSpPr/>
          <p:nvPr/>
        </p:nvCxnSpPr>
        <p:spPr>
          <a:xfrm flipH="1" flipV="1">
            <a:off x="25401" y="531019"/>
            <a:ext cx="14390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kstvak 5"/>
          <p:cNvSpPr txBox="1"/>
          <p:nvPr/>
        </p:nvSpPr>
        <p:spPr>
          <a:xfrm>
            <a:off x="-28574" y="504825"/>
            <a:ext cx="89960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50" dirty="0" smtClean="0"/>
              <a:t>Similarity (%)</a:t>
            </a:r>
            <a:endParaRPr lang="nl-NL" sz="1050" dirty="0"/>
          </a:p>
        </p:txBody>
      </p:sp>
      <p:cxnSp>
        <p:nvCxnSpPr>
          <p:cNvPr id="8" name="Rechte verbindingslijn 7"/>
          <p:cNvCxnSpPr/>
          <p:nvPr/>
        </p:nvCxnSpPr>
        <p:spPr>
          <a:xfrm flipH="1" flipV="1">
            <a:off x="1459701" y="464342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Rechte verbindingslijn 8"/>
          <p:cNvCxnSpPr/>
          <p:nvPr/>
        </p:nvCxnSpPr>
        <p:spPr>
          <a:xfrm flipH="1" flipV="1">
            <a:off x="1174082" y="464339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Rechte verbindingslijn 10"/>
          <p:cNvCxnSpPr/>
          <p:nvPr/>
        </p:nvCxnSpPr>
        <p:spPr>
          <a:xfrm flipH="1" flipV="1">
            <a:off x="890844" y="464895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Rechte verbindingslijn 11"/>
          <p:cNvCxnSpPr/>
          <p:nvPr/>
        </p:nvCxnSpPr>
        <p:spPr>
          <a:xfrm flipH="1" flipV="1">
            <a:off x="607606" y="464339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Rechte verbindingslijn 12"/>
          <p:cNvCxnSpPr/>
          <p:nvPr/>
        </p:nvCxnSpPr>
        <p:spPr>
          <a:xfrm flipH="1" flipV="1">
            <a:off x="319606" y="464617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kstvak 13"/>
          <p:cNvSpPr txBox="1"/>
          <p:nvPr/>
        </p:nvSpPr>
        <p:spPr>
          <a:xfrm rot="5400000">
            <a:off x="1271164" y="210821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100</a:t>
            </a:r>
            <a:endParaRPr lang="nl-NL" sz="1000" dirty="0"/>
          </a:p>
        </p:txBody>
      </p:sp>
      <p:sp>
        <p:nvSpPr>
          <p:cNvPr id="15" name="Tekstvak 14"/>
          <p:cNvSpPr txBox="1"/>
          <p:nvPr/>
        </p:nvSpPr>
        <p:spPr>
          <a:xfrm rot="5400000">
            <a:off x="1018270" y="24574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/>
              <a:t>8</a:t>
            </a:r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16" name="Tekstvak 15"/>
          <p:cNvSpPr txBox="1"/>
          <p:nvPr/>
        </p:nvSpPr>
        <p:spPr>
          <a:xfrm rot="5400000">
            <a:off x="733155" y="24564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/>
              <a:t>6</a:t>
            </a:r>
            <a:r>
              <a:rPr lang="nl-NL" sz="1000" dirty="0" smtClean="0"/>
              <a:t>0</a:t>
            </a:r>
            <a:endParaRPr lang="nl-NL" sz="1000" dirty="0"/>
          </a:p>
        </p:txBody>
      </p:sp>
      <p:sp>
        <p:nvSpPr>
          <p:cNvPr id="17" name="Tekstvak 16"/>
          <p:cNvSpPr txBox="1"/>
          <p:nvPr/>
        </p:nvSpPr>
        <p:spPr>
          <a:xfrm rot="5400000">
            <a:off x="450493" y="24564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 smtClean="0"/>
              <a:t>40</a:t>
            </a:r>
            <a:endParaRPr lang="nl-NL" sz="1000" dirty="0"/>
          </a:p>
        </p:txBody>
      </p:sp>
      <p:sp>
        <p:nvSpPr>
          <p:cNvPr id="18" name="Tekstvak 17"/>
          <p:cNvSpPr txBox="1"/>
          <p:nvPr/>
        </p:nvSpPr>
        <p:spPr>
          <a:xfrm rot="5400000">
            <a:off x="162659" y="24389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000" dirty="0"/>
              <a:t>2</a:t>
            </a:r>
            <a:r>
              <a:rPr lang="nl-NL" sz="1000" dirty="0" smtClean="0"/>
              <a:t>0</a:t>
            </a:r>
            <a:endParaRPr lang="nl-NL" sz="1000" dirty="0"/>
          </a:p>
        </p:txBody>
      </p:sp>
    </p:spTree>
    <p:extLst>
      <p:ext uri="{BB962C8B-B14F-4D97-AF65-F5344CB8AC3E}">
        <p14:creationId xmlns:p14="http://schemas.microsoft.com/office/powerpoint/2010/main" val="1999315725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Kantoor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th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673</Words>
  <Application>Microsoft Office PowerPoint</Application>
  <PresentationFormat>Aangepast</PresentationFormat>
  <Paragraphs>588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Company>CW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ram Spruijtenburg</dc:creator>
  <cp:lastModifiedBy>Bram Spruijtenburg</cp:lastModifiedBy>
  <cp:revision>6</cp:revision>
  <dcterms:created xsi:type="dcterms:W3CDTF">2023-10-17T20:18:16Z</dcterms:created>
  <dcterms:modified xsi:type="dcterms:W3CDTF">2023-10-18T07:23:04Z</dcterms:modified>
</cp:coreProperties>
</file>